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</p:sldIdLst>
  <p:sldSz cx="6858000" cy="9906000" type="A4"/>
  <p:notesSz cx="6858000" cy="9144000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28" autoAdjust="0"/>
    <p:restoredTop sz="94660"/>
  </p:normalViewPr>
  <p:slideViewPr>
    <p:cSldViewPr snapToGrid="0">
      <p:cViewPr varScale="1">
        <p:scale>
          <a:sx n="82" d="100"/>
          <a:sy n="82" d="100"/>
        </p:scale>
        <p:origin x="-2296" y="-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BD684F-D687-3F42-9EE3-54A8C61033DE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114B9B-DF10-7745-8EC7-A18DED2B11F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502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21CC52-382D-724D-A6E7-05FD986ECAC5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74F484-75FB-1C4A-BC14-D129BF78595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7317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D615CB-A597-594E-BA17-F380889F75BE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D9FD44-2024-934C-ADBD-19B7926D8E5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49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66C3E0-4674-F24C-8674-3DB8F80DABDD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683FCC-8F6E-B443-B179-EA8AAAC481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053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CBD986-61FC-5E45-9651-3ED4D71B1C24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51DF-DD63-B34F-807F-4F2A039371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21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95B464-1DDA-3248-85B9-7D8E2D551F24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96AD14-98DC-D44D-A789-649309477A1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365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8BAD71-042B-0740-922A-E975639F01F2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124B1F-ED8A-4A40-A6AE-49454A627E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337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972940-6658-CE4C-9B01-50A12E91ED1C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82D7F-63B0-7D45-AF44-2E3459B9C47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035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98BC55-3CA2-B74D-BB64-966546C00228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3D0E92-FDF0-5146-BAFA-2DB9C8B0BF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353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81BB33-7430-E348-A142-60142DE7F2F3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9F0F34-E36B-0B4A-9657-1728D68D74F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637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96F78F-7432-CE42-9780-11B7E007F03F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B6495-37B6-D64F-9B3E-BA6055D401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185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C0B53EC-9560-8B47-ADC0-14733FA97945}" type="datetimeFigureOut">
              <a:rPr lang="en-US"/>
              <a:pPr>
                <a:defRPr/>
              </a:pPr>
              <a:t>8/2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B6767916-F992-FA41-99F4-5326C7F0838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316" y="249624"/>
            <a:ext cx="5534526" cy="14002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286049" y="1945511"/>
            <a:ext cx="620150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Table </a:t>
            </a:r>
            <a:r>
              <a:rPr lang="en-US" dirty="0" smtClean="0"/>
              <a:t>S3. Comparison of alpha diversity (Faith’s phylogenetic diversity) among sample types</a:t>
            </a:r>
          </a:p>
          <a:p>
            <a:r>
              <a:rPr lang="en-US" dirty="0"/>
              <a:t>Faith’s phylogenetic diversity as computed by QIIME’s </a:t>
            </a:r>
            <a:r>
              <a:rPr lang="en-US" dirty="0" err="1"/>
              <a:t>alpha_diversity.py</a:t>
            </a:r>
            <a:r>
              <a:rPr lang="en-US" dirty="0"/>
              <a:t> script was compared using the </a:t>
            </a:r>
            <a:r>
              <a:rPr lang="en-US" dirty="0" err="1"/>
              <a:t>compare_alpha.py</a:t>
            </a:r>
            <a:r>
              <a:rPr lang="en-US" dirty="0"/>
              <a:t> function. Microbial composition of </a:t>
            </a:r>
            <a:r>
              <a:rPr lang="en-US" dirty="0" err="1"/>
              <a:t>rhizosphere</a:t>
            </a:r>
            <a:r>
              <a:rPr lang="en-US" dirty="0"/>
              <a:t> associated with wild rice roots was significantly less diverse compared to all other samples. </a:t>
            </a:r>
          </a:p>
        </p:txBody>
      </p:sp>
    </p:spTree>
    <p:extLst>
      <p:ext uri="{BB962C8B-B14F-4D97-AF65-F5344CB8AC3E}">
        <p14:creationId xmlns:p14="http://schemas.microsoft.com/office/powerpoint/2010/main" val="2533353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40</TotalTime>
  <Words>50</Words>
  <Application>Microsoft Macintosh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 S</dc:creator>
  <cp:keywords/>
  <dc:description/>
  <cp:lastModifiedBy>Matt Shenton</cp:lastModifiedBy>
  <cp:revision>118</cp:revision>
  <dcterms:created xsi:type="dcterms:W3CDTF">2015-03-07T06:28:59Z</dcterms:created>
  <dcterms:modified xsi:type="dcterms:W3CDTF">2016-08-02T01:03:57Z</dcterms:modified>
  <cp:category/>
</cp:coreProperties>
</file>